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3" d="100"/>
          <a:sy n="63" d="100"/>
        </p:scale>
        <p:origin x="18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2770DC-B316-4EB4-8AD5-BD772D3B5782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A01E8A-17DF-4515-83F9-E74F02A4432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35676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8699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72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2268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420736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32385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6451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9786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25920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944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3942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45748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F273B-3D90-420C-A884-CCF84A5D4141}" type="datetimeFigureOut">
              <a:rPr lang="fr-FR" smtClean="0"/>
              <a:t>04/02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BC84-7566-4EEA-B534-87E16732E2B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213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PhAnim="0">
  <p:cSld>
    <p:spTree>
      <p:nvGrpSpPr>
        <p:cNvPr id="1" name=""/>
        <p:cNvGrpSpPr/>
        <p:nvPr/>
      </p:nvGrpSpPr>
      <p:grpSpPr bwMode="auto">
        <a:xfrm>
          <a:off x="0" y="0"/>
          <a:ext cx="0" cy="0"/>
          <a:chOff x="0" y="0"/>
          <a:chExt cx="0" cy="0"/>
        </a:xfrm>
      </p:grpSpPr>
      <p:sp>
        <p:nvSpPr>
          <p:cNvPr id="4" name="Google Shape;173;p20"/>
          <p:cNvSpPr txBox="1"/>
          <p:nvPr/>
        </p:nvSpPr>
        <p:spPr bwMode="auto">
          <a:xfrm>
            <a:off x="2008949" y="4957049"/>
            <a:ext cx="8715928" cy="182880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3" tIns="91423" rIns="91423" bIns="91423" anchor="t" anchorCtr="0">
            <a:noAutofit/>
          </a:bodyPr>
          <a:lstStyle/>
          <a:p>
            <a:pPr marL="0" marR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  <a:defRPr/>
            </a:pPr>
            <a:r>
              <a:rPr lang="fr-FR" sz="1500" b="1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upplementary</a:t>
            </a:r>
            <a:r>
              <a:rPr lang="fr-FR" sz="1500" b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F</a:t>
            </a:r>
            <a:r>
              <a:rPr lang="fr-FR" sz="15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igure S11</a:t>
            </a:r>
            <a:r>
              <a:rPr lang="fr-FR" sz="15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. </a:t>
            </a:r>
            <a:r>
              <a:rPr lang="fr-FR" sz="1500" b="0" i="1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Gene expression in </a:t>
            </a:r>
            <a:r>
              <a:rPr lang="fr-FR" sz="1500" b="0" i="1" dirty="0" err="1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astroglial</a:t>
            </a:r>
            <a:r>
              <a:rPr lang="fr-FR" sz="1500" b="0" i="1" dirty="0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L</a:t>
            </a:r>
            <a:r>
              <a:rPr lang="fr-FR" sz="1500" b="0" i="1" dirty="0" err="1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sr</a:t>
            </a:r>
            <a:r>
              <a:rPr lang="fr-FR" sz="1500" b="0" i="1" dirty="0" smtClean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1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mice</a:t>
            </a:r>
            <a:r>
              <a:rPr lang="fr-FR" sz="1500" b="0" i="1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vs WT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. Box plot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presentation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of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fold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expression of the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indicated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genes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for s100 calcium binding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protein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B (s100B),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omplement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component 3 (C3) and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brain-derived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neurotrophic</a:t>
            </a:r>
            <a:r>
              <a:rPr lang="fr-FR" sz="150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factor (BDNF) in 3-mo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nth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old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(n = 6)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with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respect to WT (n=6) in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hippocampus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(A) and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olfactory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bulb (B).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tatistical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ignificance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is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shown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as *</a:t>
            </a:r>
            <a:r>
              <a:rPr lang="fr-FR" sz="1500" b="0" i="1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&lt;0.05, *** </a:t>
            </a:r>
            <a:r>
              <a:rPr lang="fr-FR" sz="1500" b="0" i="1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P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&lt;0.001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omparing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</a:t>
            </a:r>
            <a:r>
              <a:rPr lang="fr-FR" sz="1500" b="0" i="0" u="none" strike="noStrike" cap="none" spc="0" dirty="0" err="1">
                <a:solidFill>
                  <a:schemeClr val="dk1"/>
                </a:solidFill>
                <a:latin typeface="Arial"/>
                <a:ea typeface="Arial"/>
                <a:cs typeface="Arial"/>
              </a:rPr>
              <a:t>cKO</a:t>
            </a:r>
            <a:r>
              <a:rPr lang="fr-FR" sz="1500" b="0" i="0" u="none" strike="noStrike" cap="none" spc="0" dirty="0">
                <a:solidFill>
                  <a:schemeClr val="dk1"/>
                </a:solidFill>
                <a:latin typeface="Arial"/>
                <a:ea typeface="Arial"/>
                <a:cs typeface="Arial"/>
              </a:rPr>
              <a:t> to WT groups. </a:t>
            </a:r>
            <a:endParaRPr sz="1500" b="0" i="0" u="none" strike="noStrike" cap="none" spc="0" dirty="0">
              <a:solidFill>
                <a:schemeClr val="dk1"/>
              </a:solidFill>
              <a:latin typeface="Arial"/>
              <a:ea typeface="Arial"/>
              <a:cs typeface="Arial"/>
            </a:endParaRPr>
          </a:p>
        </p:txBody>
      </p:sp>
      <p:pic>
        <p:nvPicPr>
          <p:cNvPr id="5" name="Google Shape;174;p20"/>
          <p:cNvPicPr/>
          <p:nvPr/>
        </p:nvPicPr>
        <p:blipFill>
          <a:blip r:embed="rId2">
            <a:alphaModFix/>
          </a:blip>
          <a:stretch/>
        </p:blipFill>
        <p:spPr bwMode="auto">
          <a:xfrm>
            <a:off x="2575063" y="539000"/>
            <a:ext cx="7041868" cy="423202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0250768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 xmlns:m="http://schemas.openxmlformats.org/officeDocument/2006/math" xmlns:w="http://schemas.openxmlformats.org/wordprocessingml/2006/main">
      <p:transition advClick="1"/>
    </mc:Fallback>
  </mc:AlternateContent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9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U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Claudepierre</dc:creator>
  <cp:lastModifiedBy>Thomas Claudepierre</cp:lastModifiedBy>
  <cp:revision>10</cp:revision>
  <dcterms:created xsi:type="dcterms:W3CDTF">2022-01-28T21:57:26Z</dcterms:created>
  <dcterms:modified xsi:type="dcterms:W3CDTF">2022-02-04T18:15:12Z</dcterms:modified>
</cp:coreProperties>
</file>